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10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09EB40-D52F-4AC1-B4DD-3C9160836395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B98710-5FDC-4C3D-98C4-8BF6E3C38A6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0659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29939A-B7AA-E287-89D1-E8B44C1EFD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8A34932-6163-3645-B477-BB8CECA27C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FA7B0A-2F69-416F-A35C-F54A79274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D24A2F-A47A-FBD3-0C74-5FFC7E34D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881B67-ECA7-D3FD-3596-C3A6ABCBF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5739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CEB02-CE2F-0A22-CE89-F9C0966F69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AD070A-DEA8-11F0-E68F-184DCED6C0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B9EE80-FE68-92BC-9441-A6B500D4B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EB6161-D5BB-6CC0-8C24-79FFF584A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371AC5-2146-8B89-B270-2E7BB6331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7815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2DA6E2-DCE1-7103-2640-A098CEDF5D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E92628A-6111-91C6-660E-BEBBD742D5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CD27EE-8AD1-AC7D-10E2-6B2C051BF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6C156D-71AD-3649-9AB8-BBC35939F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BC9EDB-6AB0-92A1-79D0-6403EB743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4251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00E426-E28D-6D6C-9615-35D7B0A478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746025-6F53-DF87-F0AF-FF8B92415BC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B6E107-A33B-B358-F647-AF067D5E9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24E0AC-C13B-3AB5-4193-481C40E2DC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815479-46D6-201A-6ACF-C32E0F338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0013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2CAE1E-8643-E46E-9BEE-F91C892C0C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1D36CB-74BD-CA0F-2772-AC6F2A9AD4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A6ABA0-FB93-1674-0FD5-4E9F001EC8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F6FED2-0E2B-F709-3343-19C298998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25EDE3-73EC-C248-30ED-3DE59B0C7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2243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855FDA-B1A0-6F10-A665-6A03E52BC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D0F574-F7CD-549B-19BF-6187A5A0B6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8006E8-EE1B-363C-7BBE-BE0AA0A8A4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E5A2EA-9CC4-EE88-B044-FBFE18078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39BF1F-4A4A-E783-8191-B052922D9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B642A1-C3F1-7328-19C8-CF26589BD5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7604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DDE945-9078-5ECE-1F9C-3A6486C273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CA33CE-EB9D-A2C0-269B-9DB7430EAD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BC7FD4-182F-43DC-946F-E1D8DE1397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6C29C80-28D6-3CFB-AE61-F0DD83568C5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66A905-0CA1-2555-5A62-5DB9EDB67D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283DD36-55F8-D857-7987-6DB72FD2C4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95EF86-CAF0-6966-A844-A5D2D7328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9838ACF-1A8F-66FD-DE80-33AE246FE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3191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4C2468-379E-07C7-B5B1-18E5B62794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4F5CC7-1E4E-2770-E40B-E44BE7921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9FBD3A-1E43-CC02-2299-79A3EFAED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027A86-2727-2C5B-B13A-D6E95FC71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7398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6E18100-E9CC-BBE2-6BFF-678BA6277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89FE46-5B7F-7ADD-1C5A-59DB8BBE8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78DAB3-C7EF-71DA-1803-C0B9EBCE2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813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34210-13F8-BBB5-E9EA-93455B5415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D20FA1-547A-47BE-8A83-22C70B52B8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140E08-B3F6-515B-377F-C103099A80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06DAAB-983A-57DD-1B12-77ECB6380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04BBA3-2EED-E2C5-03D8-5B41F7501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DB7606-1FAD-B1C5-6622-E13EC7C9E7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7902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F9C93-271B-F31F-0722-98EF3BA42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B55C7CE-4800-6F06-4EBF-03FE49C7B0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B0D31D-1A50-9FBA-FF47-9D7803D210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28E83A-480C-CDF8-D772-125353EDBD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0AEB30-C0A4-1A10-AEA4-E0AC51EC5F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FAED85-E953-CCC4-A9C3-F542753C8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5313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2B2CB1F-282F-FC17-485D-EEEB5080F7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41307D-B3E5-D80B-D09E-181ED34FC0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12A178-280B-20E6-77F1-8736D7C818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CAFC24-CFF1-48E6-846E-15BB8D310593}" type="datetimeFigureOut">
              <a:rPr lang="en-GB" smtClean="0"/>
              <a:t>18/07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AD73EA-2F26-2360-C8E4-F564E12C36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1F39A1-79E8-CC9F-9C39-60F0A39F4A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CBAD6D-085D-4A28-A0DE-9B1F02BDC3C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7606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Video 4">
            <a:hlinkClick r:id="" action="ppaction://media"/>
            <a:extLst>
              <a:ext uri="{FF2B5EF4-FFF2-40B4-BE49-F238E27FC236}">
                <a16:creationId xmlns:a16="http://schemas.microsoft.com/office/drawing/2014/main" id="{CFC4B7FB-53F9-DC8F-ADEB-48345173F1A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43337" y="790575"/>
            <a:ext cx="4505325" cy="337899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A241A53-AFAC-745D-24AC-E4D737FB3653}"/>
              </a:ext>
            </a:extLst>
          </p:cNvPr>
          <p:cNvSpPr txBox="1"/>
          <p:nvPr/>
        </p:nvSpPr>
        <p:spPr>
          <a:xfrm>
            <a:off x="3843336" y="5003759"/>
            <a:ext cx="45053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igure S1. An example video showing mouse tracking of eight anatomical landmarks to determine location and exploratory behaviour of the test mouse.</a:t>
            </a:r>
          </a:p>
        </p:txBody>
      </p:sp>
    </p:spTree>
    <p:extLst>
      <p:ext uri="{BB962C8B-B14F-4D97-AF65-F5344CB8AC3E}">
        <p14:creationId xmlns:p14="http://schemas.microsoft.com/office/powerpoint/2010/main" val="42524225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456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4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tie Landreth</dc:creator>
  <cp:lastModifiedBy>Katie Landreth</cp:lastModifiedBy>
  <cp:revision>1</cp:revision>
  <dcterms:created xsi:type="dcterms:W3CDTF">2025-07-18T13:39:05Z</dcterms:created>
  <dcterms:modified xsi:type="dcterms:W3CDTF">2025-07-18T13:42:44Z</dcterms:modified>
</cp:coreProperties>
</file>